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532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82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57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149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607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132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000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191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11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02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289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D99BA-ECC9-4278-8354-EECF4617866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8E749-2C47-428B-BCB5-6131DDD399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51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9497" y="775062"/>
            <a:ext cx="8810263" cy="520847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1071154" y="5567780"/>
            <a:ext cx="1028482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between β-</a:t>
            </a:r>
            <a:r>
              <a:rPr lang="en-US" sz="1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ematin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hibition activity (BIHA</a:t>
            </a:r>
            <a:r>
              <a:rPr lang="en-US" sz="15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µM) and anti-malarial activity (IC</a:t>
            </a:r>
            <a:r>
              <a:rPr lang="en-US" sz="15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­, </a:t>
            </a:r>
            <a:r>
              <a:rPr lang="en-US" sz="1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or reversed chloroquinolines against sensitive strain D6. A compound which had strong antimalarial activity (IC</a:t>
            </a:r>
            <a:r>
              <a:rPr lang="en-US" sz="15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2 </a:t>
            </a:r>
            <a:r>
              <a:rPr lang="en-US" sz="1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removed from the analysis due to its insoluble form in anti-hemozoin test.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447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1:28Z</dcterms:created>
  <dcterms:modified xsi:type="dcterms:W3CDTF">2020-08-04T16:28:12Z</dcterms:modified>
</cp:coreProperties>
</file>